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371" r:id="rId2"/>
    <p:sldId id="358" r:id="rId3"/>
    <p:sldId id="359" r:id="rId4"/>
    <p:sldId id="372" r:id="rId5"/>
    <p:sldId id="373" r:id="rId6"/>
    <p:sldId id="374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PENCER S ERICKSEN" initials="SSE" lastIdx="1" clrIdx="0">
    <p:extLst>
      <p:ext uri="{19B8F6BF-5375-455C-9EA6-DF929625EA0E}">
        <p15:presenceInfo xmlns:p15="http://schemas.microsoft.com/office/powerpoint/2012/main" userId="SPENCER S ERICKSE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73" autoAdjust="0"/>
    <p:restoredTop sz="74690" autoAdjust="0"/>
  </p:normalViewPr>
  <p:slideViewPr>
    <p:cSldViewPr snapToGrid="0" showGuides="1">
      <p:cViewPr varScale="1">
        <p:scale>
          <a:sx n="78" d="100"/>
          <a:sy n="78" d="100"/>
        </p:scale>
        <p:origin x="1168" y="56"/>
      </p:cViewPr>
      <p:guideLst>
        <p:guide orient="horz" pos="218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CB6B5F-86AE-461F-8AB0-7DDBB352D8DB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44646E-4A24-4E60-996C-4977EB46FF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2164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dditional File 3A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E44646E-4A24-4E60-996C-4977EB46FF0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3909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dditional File 3B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E44646E-4A24-4E60-996C-4977EB46FF0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7633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dditional File 3C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E44646E-4A24-4E60-996C-4977EB46FF0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78318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dditional File 3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E44646E-4A24-4E60-996C-4977EB46FF0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16441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dditional File 3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E44646E-4A24-4E60-996C-4977EB46FF0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11164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dditional File 3F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E44646E-4A24-4E60-996C-4977EB46FF0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9355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D46195-DED0-4847-8FEC-986B5A4A1F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0C36D3-1DE8-4687-B9C7-5152CE5BB0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B806F9-9B88-4986-ADB1-576F18043D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D9D47B-0595-4FF3-A0CF-8071BE61C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A002BA-192D-422B-9388-A506ACD68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968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F77170-9724-42AD-8F40-BB2F96A7BA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6DAF55-CC9A-4F23-981D-593F0209A6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C11922-15B8-4668-AC28-98FF4274A9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72B292-E1C2-46C3-A2C1-C49893663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5EF8AB-11C5-4416-A229-80B76CDE9C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345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44C7C59-3B20-42B1-8CBC-D448A3495A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E2B89B-52E2-42DB-9DBD-33C715F64D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2519C8-0493-47B8-BBE6-2F0893326B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195EC3-CD14-4A55-8728-1726F1B7A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5E0C95-3C89-44AA-969D-041A246CA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108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3529F6-F69B-415E-8F64-B032B08F1D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2E7B63-0E9A-4C56-930E-3A8C76915E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9BABC0-64D7-40A3-8DFE-D626893B5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DD2ED1-150B-4D26-B6C3-D0A1F5B01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B806C0-581B-4F20-9158-6767C2284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060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7E10D4-6BF3-4C08-A403-96D59E0404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57BE8F-01E3-46FD-B48C-66F0A3F8F6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DA90B8-43AC-4D11-8339-9D24D4A65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610291-05BD-41A6-A8A4-6706EAF110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5501B1-A9DC-4A1D-B857-952F6AB4D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3806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A85766-2567-4B4C-87E8-BECB9B19B2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364614-3CF2-4E6A-B727-A28FF660F8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933CD1-8E7B-4591-ACE4-8A5B17AD8F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144AC2-74F1-426D-B91B-73092C110D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DE2F4A-FF33-426D-B791-FF9EBB808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5CA4D6-07CD-40EE-95DC-47E206FF85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135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9F72B4-BFF1-41B6-80C1-21931CB11B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B6D0A0-B7A0-4E7F-A8BC-62370CB4F0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B948A0-1FD2-44A9-B153-8578AE02EB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BC4ABF-3312-460E-AD18-4C9348289D2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7433B5E-82E7-46C6-B55F-C368F1D61B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254A009-DA8F-4950-873F-2939DF7CF6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9CF8142-CE80-4CAC-8578-AAF90CF0B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6792A27-FCAD-45D4-8BF3-239B025988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803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240504-6C69-4DD8-857D-CA5773AF65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933BD0-49F3-4D0F-8F0A-7D81AF8FE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EF888C-E284-42B6-B833-F78636BB75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9EDEF84-E322-42D9-BE1C-13ACAC46A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7490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3782D5-D5BE-4491-BB4E-82F775919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A06B7A-3CB0-4460-87A7-6970211DF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6245F4-8D39-4455-A6F6-294497F0D5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83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A21308-A7EC-4739-914D-298CDB143D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604218-0658-44F6-A2F1-F41546FD2D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8E6DF5-2431-40B5-BFAA-57A6AE8360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EFBB8B-93A6-4670-8ACD-4B7C74834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56AA2E-38D3-4EDD-88A6-7E8BF4BA8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23A034-2E69-4E8E-8A7A-8EB69791E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288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BCD1BF-F1BB-43DE-A9B9-0ED1735AFF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D76C24-0F04-4C23-B277-46F87B9A39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696122-FBC4-4A33-880C-EC2A25BAAA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37E941-B190-4D2B-B376-3458E1EF16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EF12-3B0F-4779-AF72-0DC2CB2FA6D2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3D840B-7664-423C-AF2B-A81461414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63585B-8AFD-4CA8-BB64-3FEE0274A1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452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71938E-49A9-4B5C-88C7-0C2B443077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108E2E-5CE6-43E7-9244-384CE31424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979B12-140A-4D95-B6E9-1EB7BB94BFC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8EF12-3B0F-4779-AF72-0DC2CB2FA6D2}" type="datetimeFigureOut">
              <a:rPr lang="en-US" smtClean="0"/>
              <a:t>4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23B1EF-FB1C-4EAE-AACA-8B27338A5F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2D546E-1CBC-4768-B450-CA29BE92A7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423535-1951-4588-9904-02A4E68B04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1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9883EC8E-55F4-0004-58E5-F77498018985}"/>
              </a:ext>
            </a:extLst>
          </p:cNvPr>
          <p:cNvGrpSpPr/>
          <p:nvPr/>
        </p:nvGrpSpPr>
        <p:grpSpPr>
          <a:xfrm>
            <a:off x="1173503" y="-742950"/>
            <a:ext cx="10276115" cy="7707086"/>
            <a:chOff x="1255146" y="-849086"/>
            <a:chExt cx="10276115" cy="7707086"/>
          </a:xfrm>
        </p:grpSpPr>
        <p:pic>
          <p:nvPicPr>
            <p:cNvPr id="6" name="Picture 5" descr="A colorful image of a galaxy&#10;&#10;Description automatically generated">
              <a:extLst>
                <a:ext uri="{FF2B5EF4-FFF2-40B4-BE49-F238E27FC236}">
                  <a16:creationId xmlns:a16="http://schemas.microsoft.com/office/drawing/2014/main" id="{C1CFCCE1-B9DD-4490-5037-7A07F3B5BAF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55146" y="-849086"/>
              <a:ext cx="10276115" cy="7707086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6DB04B0-0303-A1AE-65C2-A7537DADB418}"/>
                </a:ext>
              </a:extLst>
            </p:cNvPr>
            <p:cNvSpPr txBox="1"/>
            <p:nvPr/>
          </p:nvSpPr>
          <p:spPr>
            <a:xfrm>
              <a:off x="7767231" y="203690"/>
              <a:ext cx="2616422" cy="28007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MAP – 2D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CFP6 (2048), Jaccard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N=50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D=0.25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our 20 levels</a:t>
              </a:r>
            </a:p>
            <a:p>
              <a:endParaRPr lang="en-US" sz="16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6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5653 molecules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3794 inactive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59 active (1.2%)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US" sz="1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64 clusters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US" sz="1600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 ≥ triplets </a:t>
              </a:r>
              <a:endParaRPr lang="en-US" sz="1600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EF5FC150-989A-97FA-E8E5-7B6544D165EC}"/>
              </a:ext>
            </a:extLst>
          </p:cNvPr>
          <p:cNvSpPr txBox="1"/>
          <p:nvPr/>
        </p:nvSpPr>
        <p:spPr>
          <a:xfrm>
            <a:off x="108880" y="457200"/>
            <a:ext cx="1487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A</a:t>
            </a:r>
          </a:p>
        </p:txBody>
      </p:sp>
    </p:spTree>
    <p:extLst>
      <p:ext uri="{BB962C8B-B14F-4D97-AF65-F5344CB8AC3E}">
        <p14:creationId xmlns:p14="http://schemas.microsoft.com/office/powerpoint/2010/main" val="13132933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03A790FC-8944-FF6A-5B2B-B3DBFF0A7359}"/>
              </a:ext>
            </a:extLst>
          </p:cNvPr>
          <p:cNvGrpSpPr/>
          <p:nvPr/>
        </p:nvGrpSpPr>
        <p:grpSpPr>
          <a:xfrm>
            <a:off x="1861779" y="31961"/>
            <a:ext cx="9158522" cy="6870278"/>
            <a:chOff x="1861779" y="31961"/>
            <a:chExt cx="9158522" cy="6870278"/>
          </a:xfrm>
        </p:grpSpPr>
        <p:pic>
          <p:nvPicPr>
            <p:cNvPr id="3" name="Picture 2" descr="A blue and yellow image&#10;&#10;Description automatically generated with medium confidence">
              <a:extLst>
                <a:ext uri="{FF2B5EF4-FFF2-40B4-BE49-F238E27FC236}">
                  <a16:creationId xmlns:a16="http://schemas.microsoft.com/office/drawing/2014/main" id="{70844173-3267-D6ED-ACCF-5F1FF7D5823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61779" y="31961"/>
              <a:ext cx="9158522" cy="6870278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A3C93B64-4151-BB0E-E07A-4BD6DB702082}"/>
                </a:ext>
              </a:extLst>
            </p:cNvPr>
            <p:cNvSpPr txBox="1"/>
            <p:nvPr/>
          </p:nvSpPr>
          <p:spPr>
            <a:xfrm>
              <a:off x="7284167" y="881777"/>
              <a:ext cx="2884123" cy="25853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MAP – 2D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CFP6 (2048), Jaccard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N=50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D=0.25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our 20 levels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3794 inactive</a:t>
              </a:r>
            </a:p>
            <a:p>
              <a:endParaRPr lang="en-US" dirty="0"/>
            </a:p>
            <a:p>
              <a:endParaRPr lang="en-US" dirty="0"/>
            </a:p>
            <a:p>
              <a:endParaRPr lang="en-US" dirty="0"/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15BAC673-D290-B57B-07A5-122069E26A52}"/>
              </a:ext>
            </a:extLst>
          </p:cNvPr>
          <p:cNvSpPr txBox="1"/>
          <p:nvPr/>
        </p:nvSpPr>
        <p:spPr>
          <a:xfrm>
            <a:off x="108880" y="457200"/>
            <a:ext cx="1487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B</a:t>
            </a:r>
          </a:p>
        </p:txBody>
      </p:sp>
    </p:spTree>
    <p:extLst>
      <p:ext uri="{BB962C8B-B14F-4D97-AF65-F5344CB8AC3E}">
        <p14:creationId xmlns:p14="http://schemas.microsoft.com/office/powerpoint/2010/main" val="39952847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00B23E3C-8BEB-E46D-050F-901829500578}"/>
              </a:ext>
            </a:extLst>
          </p:cNvPr>
          <p:cNvGrpSpPr/>
          <p:nvPr/>
        </p:nvGrpSpPr>
        <p:grpSpPr>
          <a:xfrm>
            <a:off x="1019210" y="-63500"/>
            <a:ext cx="10156790" cy="6921500"/>
            <a:chOff x="187359" y="-1036329"/>
            <a:chExt cx="11820491" cy="8867158"/>
          </a:xfrm>
        </p:grpSpPr>
        <p:pic>
          <p:nvPicPr>
            <p:cNvPr id="4" name="Picture 3" descr="A blue background with yellow and green spots&#10;&#10;Description automatically generated">
              <a:extLst>
                <a:ext uri="{FF2B5EF4-FFF2-40B4-BE49-F238E27FC236}">
                  <a16:creationId xmlns:a16="http://schemas.microsoft.com/office/drawing/2014/main" id="{359E4600-6B72-2926-1832-201849D8E29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7359" y="-1036329"/>
              <a:ext cx="11820491" cy="8867158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14173D95-8DEF-0070-F3C1-1F7F6D3861C9}"/>
                </a:ext>
              </a:extLst>
            </p:cNvPr>
            <p:cNvSpPr txBox="1"/>
            <p:nvPr/>
          </p:nvSpPr>
          <p:spPr>
            <a:xfrm>
              <a:off x="7496793" y="-14394"/>
              <a:ext cx="2884123" cy="34163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MAP – 2D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CFP6 (2048), Jaccard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N=50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D=0.25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our 20 levels</a:t>
              </a:r>
            </a:p>
            <a:p>
              <a:endParaRPr lang="en-US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59 active (1.2%)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US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64 clusters</a:t>
              </a:r>
            </a:p>
            <a:p>
              <a:pPr marL="742950" lvl="1" indent="-285750">
                <a:buFont typeface="Arial" panose="020B0604020202020204" pitchFamily="34" charset="0"/>
                <a:buChar char="•"/>
              </a:pPr>
              <a:r>
                <a:rPr lang="en-US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5 ≥ triplets </a:t>
              </a:r>
            </a:p>
            <a:p>
              <a:endParaRPr lang="en-US" dirty="0"/>
            </a:p>
            <a:p>
              <a:endParaRPr lang="en-US" dirty="0"/>
            </a:p>
            <a:p>
              <a:endParaRPr lang="en-US" dirty="0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1A69F91C-F2E6-E033-F839-308EF0D66B1F}"/>
              </a:ext>
            </a:extLst>
          </p:cNvPr>
          <p:cNvSpPr txBox="1"/>
          <p:nvPr/>
        </p:nvSpPr>
        <p:spPr>
          <a:xfrm>
            <a:off x="108880" y="457200"/>
            <a:ext cx="1487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C</a:t>
            </a:r>
          </a:p>
        </p:txBody>
      </p:sp>
    </p:spTree>
    <p:extLst>
      <p:ext uri="{BB962C8B-B14F-4D97-AF65-F5344CB8AC3E}">
        <p14:creationId xmlns:p14="http://schemas.microsoft.com/office/powerpoint/2010/main" val="30611553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omputer generated image&#10;&#10;Description automatically generated">
            <a:extLst>
              <a:ext uri="{FF2B5EF4-FFF2-40B4-BE49-F238E27FC236}">
                <a16:creationId xmlns:a16="http://schemas.microsoft.com/office/drawing/2014/main" id="{D63863A0-C077-3014-FFAF-D05C19483F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8602" y="471714"/>
            <a:ext cx="10514796" cy="591457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CE6AD1A-2ADC-08F9-7602-B236867F7BE5}"/>
              </a:ext>
            </a:extLst>
          </p:cNvPr>
          <p:cNvSpPr txBox="1"/>
          <p:nvPr/>
        </p:nvSpPr>
        <p:spPr>
          <a:xfrm>
            <a:off x="9154441" y="110205"/>
            <a:ext cx="269364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/>
              <a:t>O</a:t>
            </a:r>
            <a:r>
              <a:rPr lang="en-US" b="1" dirty="0"/>
              <a:t>-rich aliphatic polycycl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b="1" dirty="0"/>
              <a:t>Lightly unsaturated non-aromatic polycycl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b="1" dirty="0"/>
              <a:t>ketones, alcohols, ethers, este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b="1" dirty="0"/>
              <a:t>multi-terpenoid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b="1" dirty="0"/>
              <a:t>alpha/beta unsaturated carbonyl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D328C25-D976-CE09-A87F-ACCB737F9026}"/>
              </a:ext>
            </a:extLst>
          </p:cNvPr>
          <p:cNvSpPr txBox="1"/>
          <p:nvPr/>
        </p:nvSpPr>
        <p:spPr>
          <a:xfrm>
            <a:off x="94648" y="217714"/>
            <a:ext cx="14879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D</a:t>
            </a:r>
          </a:p>
        </p:txBody>
      </p:sp>
    </p:spTree>
    <p:extLst>
      <p:ext uri="{BB962C8B-B14F-4D97-AF65-F5344CB8AC3E}">
        <p14:creationId xmlns:p14="http://schemas.microsoft.com/office/powerpoint/2010/main" val="4412253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omputer generated image&#10;&#10;Description automatically generated">
            <a:extLst>
              <a:ext uri="{FF2B5EF4-FFF2-40B4-BE49-F238E27FC236}">
                <a16:creationId xmlns:a16="http://schemas.microsoft.com/office/drawing/2014/main" id="{1F2B6E17-148E-0DAA-322A-20C1C42A42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8914" y="428120"/>
            <a:ext cx="11088914" cy="623751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4585D4D-BF63-FE58-69F6-32E5D0BDFC70}"/>
              </a:ext>
            </a:extLst>
          </p:cNvPr>
          <p:cNvSpPr txBox="1"/>
          <p:nvPr/>
        </p:nvSpPr>
        <p:spPr>
          <a:xfrm>
            <a:off x="9249524" y="428120"/>
            <a:ext cx="2640979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nitrogenous heterocycles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biguanide-lik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imin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err="1"/>
              <a:t>ureas</a:t>
            </a:r>
            <a:endParaRPr lang="en-US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 err="1"/>
              <a:t>trizoles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4B18183-3911-649B-3A19-D2E253C7E28C}"/>
              </a:ext>
            </a:extLst>
          </p:cNvPr>
          <p:cNvSpPr txBox="1"/>
          <p:nvPr/>
        </p:nvSpPr>
        <p:spPr>
          <a:xfrm>
            <a:off x="188968" y="151121"/>
            <a:ext cx="1479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E</a:t>
            </a:r>
          </a:p>
        </p:txBody>
      </p:sp>
    </p:spTree>
    <p:extLst>
      <p:ext uri="{BB962C8B-B14F-4D97-AF65-F5344CB8AC3E}">
        <p14:creationId xmlns:p14="http://schemas.microsoft.com/office/powerpoint/2010/main" val="12450042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screenshot of a computer generated image&#10;&#10;Description automatically generated">
            <a:extLst>
              <a:ext uri="{FF2B5EF4-FFF2-40B4-BE49-F238E27FC236}">
                <a16:creationId xmlns:a16="http://schemas.microsoft.com/office/drawing/2014/main" id="{A37B0965-8F79-004F-EB8C-03AA6D15AEA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51454" y="703943"/>
            <a:ext cx="9689092" cy="545011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C52881D-3087-D51F-DE2D-965D18D59D87}"/>
              </a:ext>
            </a:extLst>
          </p:cNvPr>
          <p:cNvSpPr txBox="1"/>
          <p:nvPr/>
        </p:nvSpPr>
        <p:spPr>
          <a:xfrm>
            <a:off x="9154441" y="110205"/>
            <a:ext cx="2758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Miscellaneous</a:t>
            </a:r>
          </a:p>
        </p:txBody>
      </p:sp>
      <p:pic>
        <p:nvPicPr>
          <p:cNvPr id="2" name="Picture 1" descr="A screenshot of a computer generated image&#10;&#10;Description automatically generated">
            <a:extLst>
              <a:ext uri="{FF2B5EF4-FFF2-40B4-BE49-F238E27FC236}">
                <a16:creationId xmlns:a16="http://schemas.microsoft.com/office/drawing/2014/main" id="{DCC1A4F0-900B-5EBD-756C-260724B776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9548" y="605971"/>
            <a:ext cx="10172904" cy="572225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DFEF1FB-D6D5-C9A9-200F-98C5EED05F08}"/>
              </a:ext>
            </a:extLst>
          </p:cNvPr>
          <p:cNvSpPr txBox="1"/>
          <p:nvPr/>
        </p:nvSpPr>
        <p:spPr>
          <a:xfrm>
            <a:off x="265594" y="294871"/>
            <a:ext cx="14718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3F</a:t>
            </a:r>
          </a:p>
        </p:txBody>
      </p:sp>
    </p:spTree>
    <p:extLst>
      <p:ext uri="{BB962C8B-B14F-4D97-AF65-F5344CB8AC3E}">
        <p14:creationId xmlns:p14="http://schemas.microsoft.com/office/powerpoint/2010/main" val="26693826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26</TotalTime>
  <Words>147</Words>
  <Application>Microsoft Office PowerPoint</Application>
  <PresentationFormat>Widescreen</PresentationFormat>
  <Paragraphs>57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ata Mining Data extraction and mining from PubChem repository</dc:title>
  <dc:creator>SPENCER S ERICKSEN</dc:creator>
  <cp:lastModifiedBy>MANISH S PATANKAR</cp:lastModifiedBy>
  <cp:revision>59</cp:revision>
  <dcterms:created xsi:type="dcterms:W3CDTF">2020-08-07T08:04:12Z</dcterms:created>
  <dcterms:modified xsi:type="dcterms:W3CDTF">2024-04-25T17:36:31Z</dcterms:modified>
</cp:coreProperties>
</file>